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1268075" cy="7883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11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45106" y="1290198"/>
            <a:ext cx="9577864" cy="2744635"/>
          </a:xfrm>
        </p:spPr>
        <p:txBody>
          <a:bodyPr anchor="b"/>
          <a:lstStyle>
            <a:lvl1pPr algn="ctr">
              <a:defRPr sz="68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08510" y="4140676"/>
            <a:ext cx="8451056" cy="1903360"/>
          </a:xfrm>
        </p:spPr>
        <p:txBody>
          <a:bodyPr/>
          <a:lstStyle>
            <a:lvl1pPr marL="0" indent="0" algn="ctr">
              <a:buNone/>
              <a:defRPr sz="2759"/>
            </a:lvl1pPr>
            <a:lvl2pPr marL="525551" indent="0" algn="ctr">
              <a:buNone/>
              <a:defRPr sz="2299"/>
            </a:lvl2pPr>
            <a:lvl3pPr marL="1051103" indent="0" algn="ctr">
              <a:buNone/>
              <a:defRPr sz="2069"/>
            </a:lvl3pPr>
            <a:lvl4pPr marL="1576654" indent="0" algn="ctr">
              <a:buNone/>
              <a:defRPr sz="1839"/>
            </a:lvl4pPr>
            <a:lvl5pPr marL="2102206" indent="0" algn="ctr">
              <a:buNone/>
              <a:defRPr sz="1839"/>
            </a:lvl5pPr>
            <a:lvl6pPr marL="2627757" indent="0" algn="ctr">
              <a:buNone/>
              <a:defRPr sz="1839"/>
            </a:lvl6pPr>
            <a:lvl7pPr marL="3153308" indent="0" algn="ctr">
              <a:buNone/>
              <a:defRPr sz="1839"/>
            </a:lvl7pPr>
            <a:lvl8pPr marL="3678860" indent="0" algn="ctr">
              <a:buNone/>
              <a:defRPr sz="1839"/>
            </a:lvl8pPr>
            <a:lvl9pPr marL="4204411" indent="0" algn="ctr">
              <a:buNone/>
              <a:defRPr sz="183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43122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47974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063717" y="419725"/>
            <a:ext cx="2429679" cy="66809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4681" y="419725"/>
            <a:ext cx="7148185" cy="668092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36358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602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812" y="1965409"/>
            <a:ext cx="9718715" cy="3279327"/>
          </a:xfrm>
        </p:spPr>
        <p:txBody>
          <a:bodyPr anchor="b"/>
          <a:lstStyle>
            <a:lvl1pPr>
              <a:defRPr sz="689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8812" y="5275759"/>
            <a:ext cx="9718715" cy="1724521"/>
          </a:xfrm>
        </p:spPr>
        <p:txBody>
          <a:bodyPr/>
          <a:lstStyle>
            <a:lvl1pPr marL="0" indent="0">
              <a:buNone/>
              <a:defRPr sz="2759">
                <a:solidFill>
                  <a:schemeClr val="tx1"/>
                </a:solidFill>
              </a:defRPr>
            </a:lvl1pPr>
            <a:lvl2pPr marL="525551" indent="0">
              <a:buNone/>
              <a:defRPr sz="2299">
                <a:solidFill>
                  <a:schemeClr val="tx1">
                    <a:tint val="75000"/>
                  </a:schemeClr>
                </a:solidFill>
              </a:defRPr>
            </a:lvl2pPr>
            <a:lvl3pPr marL="1051103" indent="0">
              <a:buNone/>
              <a:defRPr sz="2069">
                <a:solidFill>
                  <a:schemeClr val="tx1">
                    <a:tint val="75000"/>
                  </a:schemeClr>
                </a:solidFill>
              </a:defRPr>
            </a:lvl3pPr>
            <a:lvl4pPr marL="1576654" indent="0">
              <a:buNone/>
              <a:defRPr sz="1839">
                <a:solidFill>
                  <a:schemeClr val="tx1">
                    <a:tint val="75000"/>
                  </a:schemeClr>
                </a:solidFill>
              </a:defRPr>
            </a:lvl4pPr>
            <a:lvl5pPr marL="2102206" indent="0">
              <a:buNone/>
              <a:defRPr sz="1839">
                <a:solidFill>
                  <a:schemeClr val="tx1">
                    <a:tint val="75000"/>
                  </a:schemeClr>
                </a:solidFill>
              </a:defRPr>
            </a:lvl5pPr>
            <a:lvl6pPr marL="2627757" indent="0">
              <a:buNone/>
              <a:defRPr sz="1839">
                <a:solidFill>
                  <a:schemeClr val="tx1">
                    <a:tint val="75000"/>
                  </a:schemeClr>
                </a:solidFill>
              </a:defRPr>
            </a:lvl6pPr>
            <a:lvl7pPr marL="3153308" indent="0">
              <a:buNone/>
              <a:defRPr sz="1839">
                <a:solidFill>
                  <a:schemeClr val="tx1">
                    <a:tint val="75000"/>
                  </a:schemeClr>
                </a:solidFill>
              </a:defRPr>
            </a:lvl7pPr>
            <a:lvl8pPr marL="3678860" indent="0">
              <a:buNone/>
              <a:defRPr sz="1839">
                <a:solidFill>
                  <a:schemeClr val="tx1">
                    <a:tint val="75000"/>
                  </a:schemeClr>
                </a:solidFill>
              </a:defRPr>
            </a:lvl8pPr>
            <a:lvl9pPr marL="4204411" indent="0">
              <a:buNone/>
              <a:defRPr sz="183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0801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74680" y="2098624"/>
            <a:ext cx="4788932" cy="50020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04463" y="2098624"/>
            <a:ext cx="4788932" cy="50020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1955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6148" y="419726"/>
            <a:ext cx="9718715" cy="1523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6149" y="1932559"/>
            <a:ext cx="4766923" cy="947117"/>
          </a:xfrm>
        </p:spPr>
        <p:txBody>
          <a:bodyPr anchor="b"/>
          <a:lstStyle>
            <a:lvl1pPr marL="0" indent="0">
              <a:buNone/>
              <a:defRPr sz="2759" b="1"/>
            </a:lvl1pPr>
            <a:lvl2pPr marL="525551" indent="0">
              <a:buNone/>
              <a:defRPr sz="2299" b="1"/>
            </a:lvl2pPr>
            <a:lvl3pPr marL="1051103" indent="0">
              <a:buNone/>
              <a:defRPr sz="2069" b="1"/>
            </a:lvl3pPr>
            <a:lvl4pPr marL="1576654" indent="0">
              <a:buNone/>
              <a:defRPr sz="1839" b="1"/>
            </a:lvl4pPr>
            <a:lvl5pPr marL="2102206" indent="0">
              <a:buNone/>
              <a:defRPr sz="1839" b="1"/>
            </a:lvl5pPr>
            <a:lvl6pPr marL="2627757" indent="0">
              <a:buNone/>
              <a:defRPr sz="1839" b="1"/>
            </a:lvl6pPr>
            <a:lvl7pPr marL="3153308" indent="0">
              <a:buNone/>
              <a:defRPr sz="1839" b="1"/>
            </a:lvl7pPr>
            <a:lvl8pPr marL="3678860" indent="0">
              <a:buNone/>
              <a:defRPr sz="1839" b="1"/>
            </a:lvl8pPr>
            <a:lvl9pPr marL="4204411" indent="0">
              <a:buNone/>
              <a:defRPr sz="183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6149" y="2879677"/>
            <a:ext cx="4766923" cy="4235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704463" y="1932559"/>
            <a:ext cx="4790400" cy="947117"/>
          </a:xfrm>
        </p:spPr>
        <p:txBody>
          <a:bodyPr anchor="b"/>
          <a:lstStyle>
            <a:lvl1pPr marL="0" indent="0">
              <a:buNone/>
              <a:defRPr sz="2759" b="1"/>
            </a:lvl1pPr>
            <a:lvl2pPr marL="525551" indent="0">
              <a:buNone/>
              <a:defRPr sz="2299" b="1"/>
            </a:lvl2pPr>
            <a:lvl3pPr marL="1051103" indent="0">
              <a:buNone/>
              <a:defRPr sz="2069" b="1"/>
            </a:lvl3pPr>
            <a:lvl4pPr marL="1576654" indent="0">
              <a:buNone/>
              <a:defRPr sz="1839" b="1"/>
            </a:lvl4pPr>
            <a:lvl5pPr marL="2102206" indent="0">
              <a:buNone/>
              <a:defRPr sz="1839" b="1"/>
            </a:lvl5pPr>
            <a:lvl6pPr marL="2627757" indent="0">
              <a:buNone/>
              <a:defRPr sz="1839" b="1"/>
            </a:lvl6pPr>
            <a:lvl7pPr marL="3153308" indent="0">
              <a:buNone/>
              <a:defRPr sz="1839" b="1"/>
            </a:lvl7pPr>
            <a:lvl8pPr marL="3678860" indent="0">
              <a:buNone/>
              <a:defRPr sz="1839" b="1"/>
            </a:lvl8pPr>
            <a:lvl9pPr marL="4204411" indent="0">
              <a:buNone/>
              <a:defRPr sz="183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704463" y="2879677"/>
            <a:ext cx="4790400" cy="4235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6464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7353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84266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6148" y="525568"/>
            <a:ext cx="3634247" cy="1839489"/>
          </a:xfrm>
        </p:spPr>
        <p:txBody>
          <a:bodyPr anchor="b"/>
          <a:lstStyle>
            <a:lvl1pPr>
              <a:defRPr sz="367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90400" y="1135084"/>
            <a:ext cx="5704463" cy="5602412"/>
          </a:xfrm>
        </p:spPr>
        <p:txBody>
          <a:bodyPr/>
          <a:lstStyle>
            <a:lvl1pPr>
              <a:defRPr sz="3678"/>
            </a:lvl1pPr>
            <a:lvl2pPr>
              <a:defRPr sz="3219"/>
            </a:lvl2pPr>
            <a:lvl3pPr>
              <a:defRPr sz="2759"/>
            </a:lvl3pPr>
            <a:lvl4pPr>
              <a:defRPr sz="2299"/>
            </a:lvl4pPr>
            <a:lvl5pPr>
              <a:defRPr sz="2299"/>
            </a:lvl5pPr>
            <a:lvl6pPr>
              <a:defRPr sz="2299"/>
            </a:lvl6pPr>
            <a:lvl7pPr>
              <a:defRPr sz="2299"/>
            </a:lvl7pPr>
            <a:lvl8pPr>
              <a:defRPr sz="2299"/>
            </a:lvl8pPr>
            <a:lvl9pPr>
              <a:defRPr sz="22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76148" y="2365057"/>
            <a:ext cx="3634247" cy="4381562"/>
          </a:xfrm>
        </p:spPr>
        <p:txBody>
          <a:bodyPr/>
          <a:lstStyle>
            <a:lvl1pPr marL="0" indent="0">
              <a:buNone/>
              <a:defRPr sz="1839"/>
            </a:lvl1pPr>
            <a:lvl2pPr marL="525551" indent="0">
              <a:buNone/>
              <a:defRPr sz="1609"/>
            </a:lvl2pPr>
            <a:lvl3pPr marL="1051103" indent="0">
              <a:buNone/>
              <a:defRPr sz="1379"/>
            </a:lvl3pPr>
            <a:lvl4pPr marL="1576654" indent="0">
              <a:buNone/>
              <a:defRPr sz="1150"/>
            </a:lvl4pPr>
            <a:lvl5pPr marL="2102206" indent="0">
              <a:buNone/>
              <a:defRPr sz="1150"/>
            </a:lvl5pPr>
            <a:lvl6pPr marL="2627757" indent="0">
              <a:buNone/>
              <a:defRPr sz="1150"/>
            </a:lvl6pPr>
            <a:lvl7pPr marL="3153308" indent="0">
              <a:buNone/>
              <a:defRPr sz="1150"/>
            </a:lvl7pPr>
            <a:lvl8pPr marL="3678860" indent="0">
              <a:buNone/>
              <a:defRPr sz="1150"/>
            </a:lvl8pPr>
            <a:lvl9pPr marL="4204411" indent="0">
              <a:buNone/>
              <a:defRPr sz="11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3246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6148" y="525568"/>
            <a:ext cx="3634247" cy="1839489"/>
          </a:xfrm>
        </p:spPr>
        <p:txBody>
          <a:bodyPr anchor="b"/>
          <a:lstStyle>
            <a:lvl1pPr>
              <a:defRPr sz="367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790400" y="1135084"/>
            <a:ext cx="5704463" cy="5602412"/>
          </a:xfrm>
        </p:spPr>
        <p:txBody>
          <a:bodyPr anchor="t"/>
          <a:lstStyle>
            <a:lvl1pPr marL="0" indent="0">
              <a:buNone/>
              <a:defRPr sz="3678"/>
            </a:lvl1pPr>
            <a:lvl2pPr marL="525551" indent="0">
              <a:buNone/>
              <a:defRPr sz="3219"/>
            </a:lvl2pPr>
            <a:lvl3pPr marL="1051103" indent="0">
              <a:buNone/>
              <a:defRPr sz="2759"/>
            </a:lvl3pPr>
            <a:lvl4pPr marL="1576654" indent="0">
              <a:buNone/>
              <a:defRPr sz="2299"/>
            </a:lvl4pPr>
            <a:lvl5pPr marL="2102206" indent="0">
              <a:buNone/>
              <a:defRPr sz="2299"/>
            </a:lvl5pPr>
            <a:lvl6pPr marL="2627757" indent="0">
              <a:buNone/>
              <a:defRPr sz="2299"/>
            </a:lvl6pPr>
            <a:lvl7pPr marL="3153308" indent="0">
              <a:buNone/>
              <a:defRPr sz="2299"/>
            </a:lvl7pPr>
            <a:lvl8pPr marL="3678860" indent="0">
              <a:buNone/>
              <a:defRPr sz="2299"/>
            </a:lvl8pPr>
            <a:lvl9pPr marL="4204411" indent="0">
              <a:buNone/>
              <a:defRPr sz="22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76148" y="2365057"/>
            <a:ext cx="3634247" cy="4381562"/>
          </a:xfrm>
        </p:spPr>
        <p:txBody>
          <a:bodyPr/>
          <a:lstStyle>
            <a:lvl1pPr marL="0" indent="0">
              <a:buNone/>
              <a:defRPr sz="1839"/>
            </a:lvl1pPr>
            <a:lvl2pPr marL="525551" indent="0">
              <a:buNone/>
              <a:defRPr sz="1609"/>
            </a:lvl2pPr>
            <a:lvl3pPr marL="1051103" indent="0">
              <a:buNone/>
              <a:defRPr sz="1379"/>
            </a:lvl3pPr>
            <a:lvl4pPr marL="1576654" indent="0">
              <a:buNone/>
              <a:defRPr sz="1150"/>
            </a:lvl4pPr>
            <a:lvl5pPr marL="2102206" indent="0">
              <a:buNone/>
              <a:defRPr sz="1150"/>
            </a:lvl5pPr>
            <a:lvl6pPr marL="2627757" indent="0">
              <a:buNone/>
              <a:defRPr sz="1150"/>
            </a:lvl6pPr>
            <a:lvl7pPr marL="3153308" indent="0">
              <a:buNone/>
              <a:defRPr sz="1150"/>
            </a:lvl7pPr>
            <a:lvl8pPr marL="3678860" indent="0">
              <a:buNone/>
              <a:defRPr sz="1150"/>
            </a:lvl8pPr>
            <a:lvl9pPr marL="4204411" indent="0">
              <a:buNone/>
              <a:defRPr sz="11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991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74680" y="419726"/>
            <a:ext cx="9718715" cy="1523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4680" y="2098624"/>
            <a:ext cx="9718715" cy="50020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74680" y="7306861"/>
            <a:ext cx="2535317" cy="4197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7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04942-28D8-4A62-8391-1AC2478F3964}" type="datetimeFigureOut">
              <a:rPr lang="en-IN" smtClean="0"/>
              <a:t>17-0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32550" y="7306861"/>
            <a:ext cx="3802975" cy="4197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7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958078" y="7306861"/>
            <a:ext cx="2535317" cy="4197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7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A2715-DEE8-49E4-8E3C-AD881CCB313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8338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51103" rtl="0" eaLnBrk="1" latinLnBrk="0" hangingPunct="1">
        <a:lnSpc>
          <a:spcPct val="90000"/>
        </a:lnSpc>
        <a:spcBef>
          <a:spcPct val="0"/>
        </a:spcBef>
        <a:buNone/>
        <a:defRPr sz="50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2776" indent="-262776" algn="l" defTabSz="1051103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3219" kern="1200">
          <a:solidFill>
            <a:schemeClr val="tx1"/>
          </a:solidFill>
          <a:latin typeface="+mn-lt"/>
          <a:ea typeface="+mn-ea"/>
          <a:cs typeface="+mn-cs"/>
        </a:defRPr>
      </a:lvl1pPr>
      <a:lvl2pPr marL="788327" indent="-262776" algn="l" defTabSz="1051103" rtl="0" eaLnBrk="1" latinLnBrk="0" hangingPunct="1">
        <a:lnSpc>
          <a:spcPct val="90000"/>
        </a:lnSpc>
        <a:spcBef>
          <a:spcPts val="575"/>
        </a:spcBef>
        <a:buFont typeface="Arial" panose="020B0604020202020204" pitchFamily="34" charset="0"/>
        <a:buChar char="•"/>
        <a:defRPr sz="2759" kern="1200">
          <a:solidFill>
            <a:schemeClr val="tx1"/>
          </a:solidFill>
          <a:latin typeface="+mn-lt"/>
          <a:ea typeface="+mn-ea"/>
          <a:cs typeface="+mn-cs"/>
        </a:defRPr>
      </a:lvl2pPr>
      <a:lvl3pPr marL="1313879" indent="-262776" algn="l" defTabSz="1051103" rtl="0" eaLnBrk="1" latinLnBrk="0" hangingPunct="1">
        <a:lnSpc>
          <a:spcPct val="90000"/>
        </a:lnSpc>
        <a:spcBef>
          <a:spcPts val="575"/>
        </a:spcBef>
        <a:buFont typeface="Arial" panose="020B0604020202020204" pitchFamily="34" charset="0"/>
        <a:buChar char="•"/>
        <a:defRPr sz="2299" kern="1200">
          <a:solidFill>
            <a:schemeClr val="tx1"/>
          </a:solidFill>
          <a:latin typeface="+mn-lt"/>
          <a:ea typeface="+mn-ea"/>
          <a:cs typeface="+mn-cs"/>
        </a:defRPr>
      </a:lvl3pPr>
      <a:lvl4pPr marL="1839430" indent="-262776" algn="l" defTabSz="1051103" rtl="0" eaLnBrk="1" latinLnBrk="0" hangingPunct="1">
        <a:lnSpc>
          <a:spcPct val="90000"/>
        </a:lnSpc>
        <a:spcBef>
          <a:spcPts val="575"/>
        </a:spcBef>
        <a:buFont typeface="Arial" panose="020B0604020202020204" pitchFamily="34" charset="0"/>
        <a:buChar char="•"/>
        <a:defRPr sz="2069" kern="1200">
          <a:solidFill>
            <a:schemeClr val="tx1"/>
          </a:solidFill>
          <a:latin typeface="+mn-lt"/>
          <a:ea typeface="+mn-ea"/>
          <a:cs typeface="+mn-cs"/>
        </a:defRPr>
      </a:lvl4pPr>
      <a:lvl5pPr marL="2364981" indent="-262776" algn="l" defTabSz="1051103" rtl="0" eaLnBrk="1" latinLnBrk="0" hangingPunct="1">
        <a:lnSpc>
          <a:spcPct val="90000"/>
        </a:lnSpc>
        <a:spcBef>
          <a:spcPts val="575"/>
        </a:spcBef>
        <a:buFont typeface="Arial" panose="020B0604020202020204" pitchFamily="34" charset="0"/>
        <a:buChar char="•"/>
        <a:defRPr sz="2069" kern="1200">
          <a:solidFill>
            <a:schemeClr val="tx1"/>
          </a:solidFill>
          <a:latin typeface="+mn-lt"/>
          <a:ea typeface="+mn-ea"/>
          <a:cs typeface="+mn-cs"/>
        </a:defRPr>
      </a:lvl5pPr>
      <a:lvl6pPr marL="2890533" indent="-262776" algn="l" defTabSz="1051103" rtl="0" eaLnBrk="1" latinLnBrk="0" hangingPunct="1">
        <a:lnSpc>
          <a:spcPct val="90000"/>
        </a:lnSpc>
        <a:spcBef>
          <a:spcPts val="575"/>
        </a:spcBef>
        <a:buFont typeface="Arial" panose="020B0604020202020204" pitchFamily="34" charset="0"/>
        <a:buChar char="•"/>
        <a:defRPr sz="2069" kern="1200">
          <a:solidFill>
            <a:schemeClr val="tx1"/>
          </a:solidFill>
          <a:latin typeface="+mn-lt"/>
          <a:ea typeface="+mn-ea"/>
          <a:cs typeface="+mn-cs"/>
        </a:defRPr>
      </a:lvl6pPr>
      <a:lvl7pPr marL="3416084" indent="-262776" algn="l" defTabSz="1051103" rtl="0" eaLnBrk="1" latinLnBrk="0" hangingPunct="1">
        <a:lnSpc>
          <a:spcPct val="90000"/>
        </a:lnSpc>
        <a:spcBef>
          <a:spcPts val="575"/>
        </a:spcBef>
        <a:buFont typeface="Arial" panose="020B0604020202020204" pitchFamily="34" charset="0"/>
        <a:buChar char="•"/>
        <a:defRPr sz="2069" kern="1200">
          <a:solidFill>
            <a:schemeClr val="tx1"/>
          </a:solidFill>
          <a:latin typeface="+mn-lt"/>
          <a:ea typeface="+mn-ea"/>
          <a:cs typeface="+mn-cs"/>
        </a:defRPr>
      </a:lvl7pPr>
      <a:lvl8pPr marL="3941636" indent="-262776" algn="l" defTabSz="1051103" rtl="0" eaLnBrk="1" latinLnBrk="0" hangingPunct="1">
        <a:lnSpc>
          <a:spcPct val="90000"/>
        </a:lnSpc>
        <a:spcBef>
          <a:spcPts val="575"/>
        </a:spcBef>
        <a:buFont typeface="Arial" panose="020B0604020202020204" pitchFamily="34" charset="0"/>
        <a:buChar char="•"/>
        <a:defRPr sz="2069" kern="1200">
          <a:solidFill>
            <a:schemeClr val="tx1"/>
          </a:solidFill>
          <a:latin typeface="+mn-lt"/>
          <a:ea typeface="+mn-ea"/>
          <a:cs typeface="+mn-cs"/>
        </a:defRPr>
      </a:lvl8pPr>
      <a:lvl9pPr marL="4467187" indent="-262776" algn="l" defTabSz="1051103" rtl="0" eaLnBrk="1" latinLnBrk="0" hangingPunct="1">
        <a:lnSpc>
          <a:spcPct val="90000"/>
        </a:lnSpc>
        <a:spcBef>
          <a:spcPts val="575"/>
        </a:spcBef>
        <a:buFont typeface="Arial" panose="020B0604020202020204" pitchFamily="34" charset="0"/>
        <a:buChar char="•"/>
        <a:defRPr sz="20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1pPr>
      <a:lvl2pPr marL="525551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2pPr>
      <a:lvl3pPr marL="1051103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3pPr>
      <a:lvl4pPr marL="1576654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4pPr>
      <a:lvl5pPr marL="2102206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5pPr>
      <a:lvl6pPr marL="2627757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6pPr>
      <a:lvl7pPr marL="3153308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7pPr>
      <a:lvl8pPr marL="3678860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8pPr>
      <a:lvl9pPr marL="4204411" algn="l" defTabSz="1051103" rtl="0" eaLnBrk="1" latinLnBrk="0" hangingPunct="1">
        <a:defRPr sz="20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7F65A70-7159-4BAF-B676-C3798C84781B}"/>
              </a:ext>
            </a:extLst>
          </p:cNvPr>
          <p:cNvGrpSpPr/>
          <p:nvPr/>
        </p:nvGrpSpPr>
        <p:grpSpPr>
          <a:xfrm>
            <a:off x="151042" y="-26508"/>
            <a:ext cx="11117033" cy="7768974"/>
            <a:chOff x="151042" y="-26508"/>
            <a:chExt cx="11117033" cy="776897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5418802-F48E-45A8-BB6C-B74CB0AA5DC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1042" y="435158"/>
              <a:ext cx="3402811" cy="6687484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B576FCE-6D62-499D-B27C-AB73BFD825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64325" y="435157"/>
              <a:ext cx="4001516" cy="668748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E26AC83-DC89-4C34-9F19-6A5355F3AEB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734993" y="461665"/>
              <a:ext cx="3419714" cy="6687485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7543347-49C3-442E-87C4-C71D1355561D}"/>
                </a:ext>
              </a:extLst>
            </p:cNvPr>
            <p:cNvSpPr txBox="1"/>
            <p:nvPr/>
          </p:nvSpPr>
          <p:spPr>
            <a:xfrm>
              <a:off x="1358900" y="0"/>
              <a:ext cx="4826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8292B71-D59A-4C04-9FD0-24529676B4A7}"/>
                </a:ext>
              </a:extLst>
            </p:cNvPr>
            <p:cNvSpPr txBox="1"/>
            <p:nvPr/>
          </p:nvSpPr>
          <p:spPr>
            <a:xfrm>
              <a:off x="5665083" y="-26508"/>
              <a:ext cx="4826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297D91F-6B3C-4163-8CD4-2938614E817E}"/>
                </a:ext>
              </a:extLst>
            </p:cNvPr>
            <p:cNvSpPr txBox="1"/>
            <p:nvPr/>
          </p:nvSpPr>
          <p:spPr>
            <a:xfrm>
              <a:off x="9294471" y="19660"/>
              <a:ext cx="4826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n-IN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8A9D3F3-58B9-49C7-96B4-679C63E1BD1B}"/>
                </a:ext>
              </a:extLst>
            </p:cNvPr>
            <p:cNvSpPr txBox="1"/>
            <p:nvPr/>
          </p:nvSpPr>
          <p:spPr>
            <a:xfrm>
              <a:off x="304800" y="7373134"/>
              <a:ext cx="109632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sualization of alignments and QMEAN score (shown in blue bars) of model 1, 2, and 3 with template 5NQD   </a:t>
              </a:r>
              <a:endParaRPr lang="en-I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46684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26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ti</dc:creator>
  <cp:lastModifiedBy>Kriti</cp:lastModifiedBy>
  <cp:revision>7</cp:revision>
  <dcterms:created xsi:type="dcterms:W3CDTF">2021-02-16T06:08:00Z</dcterms:created>
  <dcterms:modified xsi:type="dcterms:W3CDTF">2021-02-17T09:21:10Z</dcterms:modified>
</cp:coreProperties>
</file>